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-1662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3EEAE-B155-4F94-92D7-0AC4059381D9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81176-2402-4377-9EEF-CB6320885E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040112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3EEAE-B155-4F94-92D7-0AC4059381D9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81176-2402-4377-9EEF-CB6320885E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037403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3EEAE-B155-4F94-92D7-0AC4059381D9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81176-2402-4377-9EEF-CB6320885E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833769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3EEAE-B155-4F94-92D7-0AC4059381D9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81176-2402-4377-9EEF-CB6320885E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950663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3EEAE-B155-4F94-92D7-0AC4059381D9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81176-2402-4377-9EEF-CB6320885E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886620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3EEAE-B155-4F94-92D7-0AC4059381D9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81176-2402-4377-9EEF-CB6320885E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902455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3EEAE-B155-4F94-92D7-0AC4059381D9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81176-2402-4377-9EEF-CB6320885E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419902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3EEAE-B155-4F94-92D7-0AC4059381D9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81176-2402-4377-9EEF-CB6320885E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567992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3EEAE-B155-4F94-92D7-0AC4059381D9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81176-2402-4377-9EEF-CB6320885E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719165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3EEAE-B155-4F94-92D7-0AC4059381D9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81176-2402-4377-9EEF-CB6320885E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304519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3EEAE-B155-4F94-92D7-0AC4059381D9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81176-2402-4377-9EEF-CB6320885E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505120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93EEAE-B155-4F94-92D7-0AC4059381D9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981176-2402-4377-9EEF-CB6320885E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983347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hteck 6"/>
          <p:cNvSpPr/>
          <p:nvPr/>
        </p:nvSpPr>
        <p:spPr>
          <a:xfrm>
            <a:off x="107504" y="8407"/>
            <a:ext cx="8928992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lnSpc>
                <a:spcPct val="150000"/>
              </a:lnSpc>
            </a:pPr>
            <a:r>
              <a:rPr lang="de-DE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4 Table. </a:t>
            </a:r>
            <a:r>
              <a:rPr lang="de-DE" sz="1000" b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ixel</a:t>
            </a:r>
            <a:r>
              <a:rPr lang="de-DE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nsities</a:t>
            </a:r>
            <a:r>
              <a:rPr lang="de-DE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asured</a:t>
            </a:r>
            <a:r>
              <a:rPr lang="de-DE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000" b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de-DE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tracts</a:t>
            </a:r>
            <a:r>
              <a:rPr lang="de-DE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ortic</a:t>
            </a:r>
            <a:r>
              <a:rPr lang="de-DE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issue</a:t>
            </a:r>
            <a:r>
              <a:rPr lang="de-DE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de-DE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cending</a:t>
            </a:r>
            <a:r>
              <a:rPr lang="de-DE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ortic</a:t>
            </a:r>
            <a:r>
              <a:rPr lang="de-DE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eurysms</a:t>
            </a:r>
            <a:endParaRPr lang="de-DE" sz="1000" b="1" dirty="0" smtClean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0">
              <a:lnSpc>
                <a:spcPct val="150000"/>
              </a:lnSpc>
            </a:pPr>
            <a:r>
              <a:rPr lang="de-DE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: Experiment 1; B. Experiment </a:t>
            </a:r>
            <a:r>
              <a:rPr lang="de-DE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de-DE" sz="1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" name="Tabel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46189992"/>
              </p:ext>
            </p:extLst>
          </p:nvPr>
        </p:nvGraphicFramePr>
        <p:xfrm>
          <a:off x="35496" y="929626"/>
          <a:ext cx="4445000" cy="444817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08000"/>
                <a:gridCol w="762000"/>
                <a:gridCol w="762000"/>
                <a:gridCol w="825500"/>
                <a:gridCol w="825500"/>
                <a:gridCol w="762000"/>
              </a:tblGrid>
              <a:tr h="48577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sample 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pixel density sample pro- MMP-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relative pixel density pro-MMP-2 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pixel density sample active MMP-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relative pixel density active MMP-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pixel density standard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928640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18.3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12613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42.4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01099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109790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01.9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62084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32.3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01099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854215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70.4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31013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6.1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01099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648315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29.3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526790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30.4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01099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227371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44.9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87396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7.3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01099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750193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18.5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28132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36.0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632740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327354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1.7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84966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9.2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632740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672391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34.1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94666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38.8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01099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0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756615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50.9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40208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7.9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01099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072091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13.9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72749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4.4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01099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8952640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78.6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24349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44.7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01099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799715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59.5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12796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42.4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01099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032029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05.9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321356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64.1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01099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797608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59.1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29986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45.90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01099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712754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42.2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85737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37.0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01099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994758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57.2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66398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42.10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632740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521134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95.1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322139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41.3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779596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0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082998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38.9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309207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39.6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779596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1850690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52.0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23827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8.7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779596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147117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47.1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35381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30.1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779596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28844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67.8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365494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46.8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779596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023288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31.2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53139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32.4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779596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3915690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61.8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10249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7.4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632740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2381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385408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60.9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>
                          <a:effectLst/>
                        </a:rPr>
                        <a:t>141498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2.3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>
                          <a:effectLst/>
                        </a:rPr>
                        <a:t>632740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  <p:graphicFrame>
        <p:nvGraphicFramePr>
          <p:cNvPr id="9" name="Tabell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96816799"/>
              </p:ext>
            </p:extLst>
          </p:nvPr>
        </p:nvGraphicFramePr>
        <p:xfrm>
          <a:off x="4572000" y="929626"/>
          <a:ext cx="4470400" cy="437197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71500"/>
                <a:gridCol w="762000"/>
                <a:gridCol w="762000"/>
                <a:gridCol w="800100"/>
                <a:gridCol w="812800"/>
                <a:gridCol w="762000"/>
              </a:tblGrid>
              <a:tr h="48577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sample 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err="1">
                          <a:effectLst/>
                        </a:rPr>
                        <a:t>pixel</a:t>
                      </a:r>
                      <a:r>
                        <a:rPr lang="de-DE" sz="1000" u="none" strike="noStrike" dirty="0">
                          <a:effectLst/>
                        </a:rPr>
                        <a:t> </a:t>
                      </a:r>
                      <a:r>
                        <a:rPr lang="de-DE" sz="1000" u="none" strike="noStrike" dirty="0" err="1">
                          <a:effectLst/>
                        </a:rPr>
                        <a:t>density</a:t>
                      </a:r>
                      <a:r>
                        <a:rPr lang="de-DE" sz="1000" u="none" strike="noStrike" dirty="0">
                          <a:effectLst/>
                        </a:rPr>
                        <a:t> sample pro- MMP-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relative pixel density pro-MMP-2 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pixel density sample active MMP-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relative pixel density active MMP-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pixel density standard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384994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9.6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20589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34.1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645604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4049820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62.7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89247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9.3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645604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38147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83.3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99464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5.4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645604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10247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79.0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39254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1.5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645604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921832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42.7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90408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44.9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645604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899725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39.3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3610740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5.9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645604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461911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71.5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20601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34.1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645604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770008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19.2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629740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40.7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645604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0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631742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97.8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15084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7.8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645604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831866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28.8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548790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3.9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645604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888937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37.6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27371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35.2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645604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616925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95.5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10659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32.6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645604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662323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24.1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23701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41.9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33416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25135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98.4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29547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4.2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33416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42830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01.7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53037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8.6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33416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9969690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86.90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99808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6.2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33416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769413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44.2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13042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39.9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33416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0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4947770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92.7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79740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4.9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33416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86908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10.0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18735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2.2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33416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57359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04.4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83352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5.6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33416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57823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48.3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66233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2.4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33416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631647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18.4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43106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6.8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33416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459952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86.2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091770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0.4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33416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>
                          <a:effectLst/>
                        </a:rPr>
                        <a:t>2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392723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73.6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98213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8.4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>
                          <a:effectLst/>
                        </a:rPr>
                        <a:t>5334166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  <p:sp>
        <p:nvSpPr>
          <p:cNvPr id="10" name="Textfeld 9"/>
          <p:cNvSpPr txBox="1"/>
          <p:nvPr/>
        </p:nvSpPr>
        <p:spPr>
          <a:xfrm>
            <a:off x="48458" y="692696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chteck 11"/>
          <p:cNvSpPr/>
          <p:nvPr/>
        </p:nvSpPr>
        <p:spPr>
          <a:xfrm>
            <a:off x="4584187" y="699909"/>
            <a:ext cx="27764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de-DE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DE" sz="1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565270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05571662"/>
              </p:ext>
            </p:extLst>
          </p:nvPr>
        </p:nvGraphicFramePr>
        <p:xfrm>
          <a:off x="107504" y="1145257"/>
          <a:ext cx="4711700" cy="437197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62000"/>
                <a:gridCol w="762000"/>
                <a:gridCol w="762000"/>
                <a:gridCol w="825500"/>
                <a:gridCol w="838200"/>
                <a:gridCol w="762000"/>
              </a:tblGrid>
              <a:tr h="48577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sample 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pixel density sample pro- MMP-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relative pixel density pro-MMP-2 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pixel density sample active MMP-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relative pixel density active MMP-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pixel density standard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363811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69.9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22006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42.70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19943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404564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77.8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95764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37.6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19943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00869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96.3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322770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5.4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19943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462759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89.00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525790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9.3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19943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806561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55.1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19656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42.2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19943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756932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45.5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80403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3.9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19943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398411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76.6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38335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45.8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19943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88218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13.1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07106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39.8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19943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0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415347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79.8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74140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4.2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19943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736342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41.6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64942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31.7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19943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700813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34.7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25420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43.3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19943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484859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93.2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99366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38.3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19943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611335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30.0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213430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45.4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469943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598289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27.3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568598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33.3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smtClean="0">
                          <a:effectLst/>
                        </a:rPr>
                        <a:t>469943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301635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64.1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74.47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2.2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smtClean="0">
                          <a:effectLst/>
                        </a:rPr>
                        <a:t>469943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929686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97.8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250296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3.2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smtClean="0">
                          <a:effectLst/>
                        </a:rPr>
                        <a:t>469943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782425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66.4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245979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2.3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smtClean="0">
                          <a:effectLst/>
                        </a:rPr>
                        <a:t>469943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0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564688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20.1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38396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9.4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smtClean="0">
                          <a:effectLst/>
                        </a:rPr>
                        <a:t>469943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639179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36.0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74108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37.0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smtClean="0">
                          <a:effectLst/>
                        </a:rPr>
                        <a:t>469943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682879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45.3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67166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35.5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smtClean="0">
                          <a:effectLst/>
                        </a:rPr>
                        <a:t>469943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266106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56.6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>
                          <a:effectLst/>
                        </a:rPr>
                        <a:t>767.406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6.3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smtClean="0">
                          <a:effectLst/>
                        </a:rPr>
                        <a:t>469943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636884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35.5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73484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36.9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smtClean="0">
                          <a:effectLst/>
                        </a:rPr>
                        <a:t>469943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480371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02.2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143425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30.5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smtClean="0">
                          <a:effectLst/>
                        </a:rPr>
                        <a:t>469943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2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3381770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71.9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720648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>
                          <a:effectLst/>
                        </a:rPr>
                        <a:t>15.3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000" u="none" strike="noStrike" dirty="0" smtClean="0">
                          <a:effectLst/>
                        </a:rPr>
                        <a:t>469943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  <p:sp>
        <p:nvSpPr>
          <p:cNvPr id="6" name="Rechteck 5"/>
          <p:cNvSpPr/>
          <p:nvPr/>
        </p:nvSpPr>
        <p:spPr>
          <a:xfrm>
            <a:off x="107504" y="908720"/>
            <a:ext cx="27764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de-DE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de-DE" sz="1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hteck 7"/>
          <p:cNvSpPr/>
          <p:nvPr/>
        </p:nvSpPr>
        <p:spPr>
          <a:xfrm>
            <a:off x="97112" y="116632"/>
            <a:ext cx="5958408" cy="7848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lnSpc>
                <a:spcPct val="150000"/>
              </a:lnSpc>
            </a:pPr>
            <a:r>
              <a:rPr lang="de-DE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4 Table.  </a:t>
            </a:r>
            <a:r>
              <a:rPr lang="de-DE" sz="1000" b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ixel</a:t>
            </a:r>
            <a:r>
              <a:rPr lang="de-DE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nsities</a:t>
            </a:r>
            <a:r>
              <a:rPr lang="de-DE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asured</a:t>
            </a:r>
            <a:r>
              <a:rPr lang="de-DE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000" b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de-DE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tracts</a:t>
            </a:r>
            <a:r>
              <a:rPr lang="de-DE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ortic</a:t>
            </a:r>
            <a:r>
              <a:rPr lang="de-DE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issue</a:t>
            </a:r>
            <a:r>
              <a:rPr lang="de-DE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de-DE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cending</a:t>
            </a:r>
            <a:r>
              <a:rPr lang="de-DE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ortic</a:t>
            </a:r>
            <a:r>
              <a:rPr lang="de-DE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eurysms</a:t>
            </a:r>
            <a:endParaRPr lang="de-DE" sz="1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0">
              <a:lnSpc>
                <a:spcPct val="150000"/>
              </a:lnSpc>
            </a:pPr>
            <a:r>
              <a:rPr lang="de-DE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de-DE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Experiment 3</a:t>
            </a:r>
          </a:p>
        </p:txBody>
      </p:sp>
    </p:spTree>
    <p:extLst>
      <p:ext uri="{BB962C8B-B14F-4D97-AF65-F5344CB8AC3E}">
        <p14:creationId xmlns:p14="http://schemas.microsoft.com/office/powerpoint/2010/main" val="2878084100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53</Words>
  <Application>Microsoft Office PowerPoint</Application>
  <PresentationFormat>Bildschirmpräsentation (4:3)</PresentationFormat>
  <Paragraphs>457</Paragraphs>
  <Slides>2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3" baseType="lpstr">
      <vt:lpstr>Larissa</vt:lpstr>
      <vt:lpstr>PowerPoint-Präsentation</vt:lpstr>
      <vt:lpstr>PowerPoint-Präsentation</vt:lpstr>
    </vt:vector>
  </TitlesOfParts>
  <Company>Uniklinikum Freibur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r. Anke Tscheuschler</dc:creator>
  <cp:lastModifiedBy>Dr. Anke Tscheuschler</cp:lastModifiedBy>
  <cp:revision>1</cp:revision>
  <dcterms:created xsi:type="dcterms:W3CDTF">2016-09-29T14:10:50Z</dcterms:created>
  <dcterms:modified xsi:type="dcterms:W3CDTF">2016-09-29T14:11:22Z</dcterms:modified>
</cp:coreProperties>
</file>